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9" autoAdjust="0"/>
    <p:restoredTop sz="94660"/>
  </p:normalViewPr>
  <p:slideViewPr>
    <p:cSldViewPr snapToGrid="0">
      <p:cViewPr varScale="1">
        <p:scale>
          <a:sx n="48" d="100"/>
          <a:sy n="48" d="100"/>
        </p:scale>
        <p:origin x="516" y="3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C280B8E-46AB-38B1-0F22-9421008C7E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B5B4863-2F6E-B55B-02EC-36D716A41C6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91D2B39-1220-4D6A-8E2C-0EF384B7F6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E8A94-E0C7-4B2A-A197-62392A891869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3B62054-D0A8-C954-3519-399B4B0B36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FE92E59-D9B3-02BF-34F6-38E46615DD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D240-6467-43E9-BAA6-C70603CE10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36528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4D0FFF1-8F0D-4240-386B-3EA9F4F7C3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4008CAF-0D42-FFB3-D5F2-175EE25790A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57C64F7-023B-F575-03A3-359149B2E0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E8A94-E0C7-4B2A-A197-62392A891869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24B0A78-77AF-8D56-3A03-8B635DAD22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25B800A-DA79-A13D-AE3C-DD70380B0C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D240-6467-43E9-BAA6-C70603CE10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65439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744A3E4E-7C78-4C10-93F4-B75DD53644B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74F5917-2160-5BAA-CB2E-EFC2E8C0D7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9C091DB-EF50-740D-58AC-3E6DC882D7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E8A94-E0C7-4B2A-A197-62392A891869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C9D2B89-BA81-8815-CA1B-257A9680FB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8A96103-F0D5-DEBE-6D77-2337565E61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D240-6467-43E9-BAA6-C70603CE10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1039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820F818-7288-4FA3-E916-C024E05462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5751638-CBEA-CDAC-3B3C-82D5D1ECE1F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DA5ABA7-4258-3C5E-DBA3-005FA9C43D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E8A94-E0C7-4B2A-A197-62392A891869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6F68FF5-E75D-65FA-0896-779BC6189E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2F8B4E8-870C-43C9-4A36-1E827D0245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D240-6467-43E9-BAA6-C70603CE10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0558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42E6734-5246-DFE9-E4B9-34809B4CF7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36D19C9-F504-415B-1231-634B2C1361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B6B9182-F012-D98D-0A2B-91C22D4F64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E8A94-E0C7-4B2A-A197-62392A891869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C7AB51E-26E2-0805-41E9-7F2D2FD2D8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695D099-0CDE-0ADF-7CF6-A1AEC9C07E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D240-6467-43E9-BAA6-C70603CE10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64141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30B6BBB-3B8A-2869-276C-8A8A4E75B5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46C157F-22EF-5334-4F4A-41AA43CCE4B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A30F013-AF2E-679F-DBA3-18560D20C2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686C2D6-4B59-3020-026A-55BBA4E123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E8A94-E0C7-4B2A-A197-62392A891869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20DB852-0048-FCC2-D45C-3E3F667B87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39BD973-8DC1-C27F-9EB7-8C943EC80C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D240-6467-43E9-BAA6-C70603CE10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24388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ACB5297-44A6-DD92-2CC7-254B7866AB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B3C71E6-3098-3E0B-BD12-7DC2780BB5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F96AECF-28DC-123E-DDD6-F0EAD2A37E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3F52B6E1-2860-C602-2F94-AECE299B58A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591F73E-EDF9-33FA-4850-75F368EAC21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BD77692-A98E-FD8C-532E-74650D38F2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E8A94-E0C7-4B2A-A197-62392A891869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00C26B07-C92A-5E8E-D00A-368B584CBB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A86F394-3A04-A0F9-7244-883B355BA2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D240-6467-43E9-BAA6-C70603CE10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02313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9F92577-DB81-C650-4DFC-7DA2316C73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D6570DC-928F-EB3B-D42A-5D3B693F1B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E8A94-E0C7-4B2A-A197-62392A891869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B590409-38FC-D5E9-3ACA-F4DFC208FC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B13D662-AABB-9D49-9D7A-FF3BA66A74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D240-6467-43E9-BAA6-C70603CE10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34310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9904843E-E787-79A8-FF69-98471B7596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E8A94-E0C7-4B2A-A197-62392A891869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FC93110-DD3C-BBBF-B53C-0B71F8567D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5730A81-D265-0EC2-DC94-D67E5EEE76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D240-6467-43E9-BAA6-C70603CE10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34977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7BC5899-98B6-9687-EBC7-1D6886F53A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76DB530-FFD1-FAF0-0305-BC74BA8E729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5B6240F-BCA4-A288-5F96-9989384BD4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D89D865-AAA9-6C0E-4015-8D9E4EE5EB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E8A94-E0C7-4B2A-A197-62392A891869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FF0E5BE-EA90-3B70-4738-98D96ABE44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CF06220-826A-C8DF-B6DF-EEB10BB265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D240-6467-43E9-BAA6-C70603CE10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18414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9ADE16C-CF6F-F39E-5808-C95694BD4C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8812173-9CCF-8DCC-B1F5-FD6D1AC224B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363E611-2F0D-75F0-2CF6-1BFB239272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AA4C353-BF8A-3605-E7B1-489F617666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CE8A94-E0C7-4B2A-A197-62392A891869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C561356-DA8E-0BD7-7EF6-6C6849C7EC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59F6F01-BC42-FCD0-F4A6-8BE51E0483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D240-6467-43E9-BAA6-C70603CE10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20712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698CF5D-0822-16D6-FB50-C2F3FBFCE3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CAFE0D5-509E-8E5A-2154-526F6AE9A3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010FCEE-750D-547F-29A0-C39472370B7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CE8A94-E0C7-4B2A-A197-62392A891869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26A80F8-9986-BBAE-E3F6-1045AECB07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0BD023B-2CF5-779B-68D5-0F3D19A580F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2BD240-6467-43E9-BAA6-C70603CE10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95828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BD8CA738-9098-93A2-CED5-55B7C3ADBD2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0056" y="1245822"/>
            <a:ext cx="7628953" cy="4593779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424B3FC2-24DE-1CDD-22FF-3C8BD809A4A0}"/>
              </a:ext>
            </a:extLst>
          </p:cNvPr>
          <p:cNvSpPr txBox="1"/>
          <p:nvPr/>
        </p:nvSpPr>
        <p:spPr>
          <a:xfrm>
            <a:off x="1773347" y="6059748"/>
            <a:ext cx="964302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800" b="1" kern="1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l </a:t>
            </a:r>
            <a:r>
              <a:rPr lang="en-US" altLang="zh-CN" b="1" kern="10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</a:t>
            </a:r>
            <a:r>
              <a:rPr lang="en-US" altLang="zh-CN" sz="1800" b="1" kern="1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g. </a:t>
            </a:r>
            <a:r>
              <a:rPr lang="en-US" altLang="zh-CN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5</a:t>
            </a:r>
            <a:r>
              <a:rPr lang="en-US" altLang="zh-CN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zh-CN" altLang="zh-CN" sz="1800" kern="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</a:t>
            </a: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ysine degradation pathway was demonstrated through the pathway mapper 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1601149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李 欢</dc:creator>
  <cp:lastModifiedBy>李 欢</cp:lastModifiedBy>
  <cp:revision>2</cp:revision>
  <dcterms:created xsi:type="dcterms:W3CDTF">2023-03-19T02:49:17Z</dcterms:created>
  <dcterms:modified xsi:type="dcterms:W3CDTF">2023-03-23T09:24:00Z</dcterms:modified>
</cp:coreProperties>
</file>